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954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D6E940-8A95-48B3-970C-ED58B30793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4873A62-C01F-4317-8E08-C25865F2CB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156F37-AB26-4716-AC76-B6B748D80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B19B73-E89A-47A5-A2B8-1FCA70648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CDFC9D-0554-4420-9975-B7E479B5D0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58011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1C1CE-6E85-4877-801B-295801B5DC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63FFC9-A73B-49C6-AD74-E36A9CAEE0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286870-09FE-49DA-A1A1-793686FF1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F8674C-F357-43D0-865F-B511C85EB9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8B9CC4-F0E8-4390-8916-BEAC883CB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881081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DA0C57-E884-4FE9-97E4-8743A374B7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9CABDCC-E633-41ED-9ED8-F915EACC6C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9956B4-4808-42BC-A287-C2CF4426F4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937FD4-A8F8-428B-8AC0-A76E4A1433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9602DC-A456-4913-B0EF-F6FE935BD0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2451008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38D756-054C-44A3-A499-C13978C7E3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53750E-2237-451B-8338-11BE6BC0D8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95A841-96C1-4938-905E-5E075CCC5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DCEB77-0D6A-466F-B486-FCEFA9E40B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E3DD18-B817-4F67-9A9F-7EB26412A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6531013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AB9A3C-381B-442F-90EE-F01B71BF3F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CF0BCC-DECC-4C38-B2DF-4A9F083591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68AB24-8F74-400C-AC3C-BECCBECC6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DF7876-0C5E-4C73-8881-389EECD4B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AFF677-7256-429F-B5AB-D1BFB4F13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98246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5EFB33-9F44-466A-910B-A5A3E1BAAA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B0364A-F334-4B38-A23B-A301570168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1F58BF-C4A5-401E-8762-70F01ABD0B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25730D-6D3A-4CCE-950E-4FAA86281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9D46F4-803B-4F4A-AD43-E20FA2F30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496844-3D4B-46FC-93A6-D0C506187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74696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D4B54D-3863-41A4-AC0C-272B4AE07D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0D62C7-2AEC-474D-8CD9-B75A7308FF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49F556-D641-4282-9C32-99E2F74F16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73E3D6-8BAC-4B87-845E-60B91B6B11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E303387-8EED-4E69-9EB7-C8A83A021D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0AC6AD-C9C0-4BF4-8667-908709395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BA95343-2353-4846-9AC1-3F9726127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683D8E-82A8-41CF-AFAC-40FD19BA6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11120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D9628-1FA8-4E20-A66B-F91081027B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16D666C-ECDD-4BDE-B0AA-88370CF28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30DC985-8A92-4FF6-BC08-217628351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1F030B4-8D8A-46FB-A6C4-B50ECCF07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929578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C1BEB1B-4964-42E8-B296-AD63F6385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866A250-AC6D-4A63-9956-C49D737E1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05FEE5-490D-4150-809B-87AA0E081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044288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C170AA-435D-4728-B8ED-EAE83CE87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959DB7-741A-4DA6-B725-5E55D242DE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9C7A6A-691E-4543-982E-BCD46C8EDF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2301B3-D5FF-45E8-B275-04D203603C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D430D2-A33C-41FA-8F03-03C840348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74FB1C-5B90-40A6-B5FD-5EE32F5D0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714967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C123B5-0E84-4E86-8F61-AF684361DA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ABD3B0-C001-496F-9190-62C8362DA5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E5982A-2E1F-4CEC-88AE-E6A8B0462A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A701ED-BB7A-417E-AB77-908F95213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BDAB21-DE7C-4FBD-ACFF-3BBD31A9E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B2A6FA-9400-47EF-A458-7FAC1A049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919172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36A049-92B3-4EFD-A6A2-ADD2FAC837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58607A-856B-48D3-85D3-34A6C5A2CC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0E69C-2EFF-4998-9481-26AE4CB346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92784-9E72-49FD-8720-4DB1C2473F3E}" type="datetimeFigureOut">
              <a:rPr lang="de-AT" smtClean="0"/>
              <a:t>14.06.2023</a:t>
            </a:fld>
            <a:endParaRPr lang="de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E0FB65-D35B-4616-8A59-7372CBC035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D12D2F-D345-48CA-BA92-574C7F2B97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5B75F-CB1D-4814-A4AB-F865A6B98962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927986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8B65FCB-C008-4931-8E50-6E6CFD8A7E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911" y="4427182"/>
            <a:ext cx="2461208" cy="233939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B5C5807-E67C-45AF-9A7B-3094251BD76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5912" y="895352"/>
            <a:ext cx="2461208" cy="233939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F6F66D4-AE2C-430E-9DB1-6247270AF4F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5028" y="895351"/>
            <a:ext cx="2461208" cy="233939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43F84F6-A060-401A-A8BC-E67E191392F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2946" y="895350"/>
            <a:ext cx="2461208" cy="233939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2D4BEFAE-07E3-4CC4-ACEE-E62C5D1E1B91}"/>
              </a:ext>
            </a:extLst>
          </p:cNvPr>
          <p:cNvSpPr txBox="1"/>
          <p:nvPr/>
        </p:nvSpPr>
        <p:spPr>
          <a:xfrm>
            <a:off x="1562405" y="192482"/>
            <a:ext cx="117961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AT" b="1" dirty="0">
                <a:latin typeface="Arial" panose="020B0604020202020204" pitchFamily="34" charset="0"/>
                <a:cs typeface="Arial" panose="020B0604020202020204" pitchFamily="34" charset="0"/>
              </a:rPr>
              <a:t>pMU131</a:t>
            </a:r>
          </a:p>
          <a:p>
            <a:pPr algn="ctr"/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Empty, 55°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D048192-30D5-48F4-9256-39A318B21566}"/>
              </a:ext>
            </a:extLst>
          </p:cNvPr>
          <p:cNvSpPr txBox="1"/>
          <p:nvPr/>
        </p:nvSpPr>
        <p:spPr>
          <a:xfrm>
            <a:off x="4707837" y="192482"/>
            <a:ext cx="214680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AT" b="1" dirty="0">
                <a:latin typeface="Arial" panose="020B0604020202020204" pitchFamily="34" charset="0"/>
                <a:cs typeface="Arial" panose="020B0604020202020204" pitchFamily="34" charset="0"/>
              </a:rPr>
              <a:t>pThermoFAST_01</a:t>
            </a:r>
          </a:p>
          <a:p>
            <a:pPr algn="ctr"/>
            <a:r>
              <a:rPr lang="de-AT" sz="1400" dirty="0" err="1">
                <a:latin typeface="Arial" panose="020B0604020202020204" pitchFamily="34" charset="0"/>
                <a:cs typeface="Arial" panose="020B0604020202020204" pitchFamily="34" charset="0"/>
              </a:rPr>
              <a:t>pPta</a:t>
            </a:r>
            <a:r>
              <a:rPr lang="de-AT" sz="14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kv</a:t>
            </a:r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, 55°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D908FE0-B46D-406F-BBA6-67D8AC7E78AD}"/>
              </a:ext>
            </a:extLst>
          </p:cNvPr>
          <p:cNvSpPr txBox="1"/>
          <p:nvPr/>
        </p:nvSpPr>
        <p:spPr>
          <a:xfrm>
            <a:off x="8565462" y="192481"/>
            <a:ext cx="214680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AT" b="1" dirty="0">
                <a:latin typeface="Arial" panose="020B0604020202020204" pitchFamily="34" charset="0"/>
                <a:cs typeface="Arial" panose="020B0604020202020204" pitchFamily="34" charset="0"/>
              </a:rPr>
              <a:t>pThermoFAST_01</a:t>
            </a:r>
          </a:p>
          <a:p>
            <a:pPr algn="ctr"/>
            <a:r>
              <a:rPr lang="de-AT" sz="1400" dirty="0" err="1">
                <a:latin typeface="Arial" panose="020B0604020202020204" pitchFamily="34" charset="0"/>
                <a:cs typeface="Arial" panose="020B0604020202020204" pitchFamily="34" charset="0"/>
              </a:rPr>
              <a:t>pPta</a:t>
            </a:r>
            <a:r>
              <a:rPr lang="de-AT" sz="14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Tkv</a:t>
            </a:r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, 66°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46597C-353B-4193-B857-6A3104EAB4B3}"/>
              </a:ext>
            </a:extLst>
          </p:cNvPr>
          <p:cNvSpPr txBox="1"/>
          <p:nvPr/>
        </p:nvSpPr>
        <p:spPr>
          <a:xfrm>
            <a:off x="1617452" y="3690007"/>
            <a:ext cx="106952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AT" b="1" dirty="0" err="1">
                <a:latin typeface="Arial" panose="020B0604020202020204" pitchFamily="34" charset="0"/>
                <a:cs typeface="Arial" panose="020B0604020202020204" pitchFamily="34" charset="0"/>
              </a:rPr>
              <a:t>Evolved</a:t>
            </a:r>
            <a:endParaRPr lang="de-AT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66°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F876A80-8C84-41FA-AFCE-94D5DDE8BC12}"/>
              </a:ext>
            </a:extLst>
          </p:cNvPr>
          <p:cNvSpPr txBox="1"/>
          <p:nvPr/>
        </p:nvSpPr>
        <p:spPr>
          <a:xfrm>
            <a:off x="3991511" y="4396664"/>
            <a:ext cx="6809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AT" b="1" dirty="0">
                <a:latin typeface="Arial" panose="020B0604020202020204" pitchFamily="34" charset="0"/>
                <a:cs typeface="Arial" panose="020B0604020202020204" pitchFamily="34" charset="0"/>
              </a:rPr>
              <a:t> File S2: </a:t>
            </a:r>
            <a:r>
              <a:rPr lang="de-AT" sz="14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4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4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400" dirty="0" err="1">
                <a:latin typeface="Arial" panose="020B0604020202020204" pitchFamily="34" charset="0"/>
                <a:cs typeface="Arial" panose="020B0604020202020204" pitchFamily="34" charset="0"/>
              </a:rPr>
              <a:t>plots</a:t>
            </a:r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AT" sz="14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AT" sz="1400" dirty="0">
                <a:latin typeface="Arial" panose="020B0604020202020204" pitchFamily="34" charset="0"/>
                <a:cs typeface="Arial" panose="020B0604020202020204" pitchFamily="34" charset="0"/>
              </a:rPr>
              <a:t> in Figure 3.</a:t>
            </a:r>
          </a:p>
        </p:txBody>
      </p:sp>
    </p:spTree>
    <p:extLst>
      <p:ext uri="{BB962C8B-B14F-4D97-AF65-F5344CB8AC3E}">
        <p14:creationId xmlns:p14="http://schemas.microsoft.com/office/powerpoint/2010/main" val="2731789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cq, Remi Vincent</dc:creator>
  <cp:lastModifiedBy>Hocq, Remi Vincent</cp:lastModifiedBy>
  <cp:revision>1</cp:revision>
  <dcterms:created xsi:type="dcterms:W3CDTF">2023-06-14T10:30:48Z</dcterms:created>
  <dcterms:modified xsi:type="dcterms:W3CDTF">2023-06-14T10:39:31Z</dcterms:modified>
</cp:coreProperties>
</file>